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8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B742F-A20F-45C1-B7C1-AF90251EB59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A394471-290D-48D3-A988-1A8924C0CAA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222C92-946D-4AA8-830B-6180367A7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D811F7-D083-4ACC-AA8A-E7EA659DD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AE2EF7-37C5-4773-BE4B-03695A7A0E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417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3B490B-6591-4188-8A75-2B438E600F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14270C-0F36-4879-BBD1-9592B65E8D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57F17C-30DF-49C5-A338-7F98246476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CE6A9E-31E8-461D-9D24-E1B0E7D98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B07E24-BAE2-49E0-92F6-E65D58168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963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6D0E1D1-FE44-4FA1-8A5F-145F2ED280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53CF90-7E10-4522-A807-21DB1F3B19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286219-B80F-4584-9250-B5CEE55A1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C069DD-DD0D-4836-B886-B422971D7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FCEBA1-658B-4F1A-9C1B-152EB5715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2359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8E08EF-BA4D-464A-8EE9-0E18F74974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4249C2-998E-43B0-BCB8-41F7B00BC90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6A5087-44A9-4BE2-9E61-4D97B0785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CC9C24-9A2F-48F7-9233-907013BB8D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5A8396-6928-4EA8-9DB6-8ECB87814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1154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EA0A17-409B-43B4-AE6C-18B9651097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12763F-067C-412D-BCCE-AFBFDBD9FB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B47413-4ABA-47BB-BD56-2B6B1399A2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62D92E-8C4E-4B3F-B187-5D96615C6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FA148D-98A8-4640-B28B-CC43957CC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913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9344C6-0B74-4CBD-B0D4-BC9584AADF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ADEC3B7-0B61-422F-A3A3-4B975A0940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515502C-F1F1-4EDA-9D6B-3C44C9E511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D31FBF-6A69-49D4-B400-B98495D279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22BAC6-8356-47F9-9C3F-8EC810DDA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1DCB34-5BD5-4002-833C-49A7A5BB0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3375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2EAB40-8AA5-4E89-8F35-CF71EE7203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8BCA68-6F6E-434D-80F8-A5BE3F365C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E460B84-0E71-437B-8608-6E6B53371E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4F8CB99-CEA1-4D3A-B8E5-31228B8751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0D7EFBA-8803-418B-97A6-3B7393FA190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36A6DF-6637-4AB7-B70D-078E1D3D9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BEAC418-4DDF-46C4-9156-B3482D7227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2B1358D-B59D-4DEC-98E1-87CA9F99FE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946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D0EEEF-BAE5-4FD4-B17B-137B6E2CB0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481882-0F8C-43F3-A3FE-097566FE73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CB3DB0F-2563-42EC-AE63-8122A82B9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255FE7-8F07-467E-BE5B-7469B9F2D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4746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3789593-3FBB-44F8-BF0D-B134126F58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FD91496-BDDC-47D8-AF4B-7DC0FA40C6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7DF98DF-3863-46D8-8CFB-17D6B82B2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356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D0D6D5-0364-492C-B9D0-C5B099CA60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DFFAB7-9DFF-4F9C-B006-DEA2D6CAF7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D5A99D6-E1BB-4BD4-BC06-973EDFB3AF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EB5197-F5A9-4AB1-A4A7-16D492BE5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4A5B43-8485-4CD8-A0D6-378AC1D4A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E92CED-A6A8-42EB-BB2B-D5D4393C1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5404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1C0B10-0856-42F6-BF17-5723A7EE6A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2139B4-9648-4E9B-9116-118A8C08BA8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65AF36-DC19-4D2B-9DB6-2A131B5595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6FB024-D1BD-446F-AA12-335A8CCF8A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9CD2C4-882C-4D23-A9AE-6D00745DA8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344211-48E9-4BE4-883E-4F9683451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343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C9793A5-341C-4D8D-9D60-344E058880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6A7202-13F2-4BC7-B5D8-BCB8ACC120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9D47EE-3B24-4701-B8A9-5655A33A60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E663E5-2A93-4042-AFBC-FDE0FD5EE278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0DF006-3802-4816-AF61-8571D8D78C6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7FAB2B-0551-47A3-980A-0A49B221F9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16218-F305-4178-A6F6-5C3319BF53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388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54681B1-3F05-40D8-9C3B-C2BFB33E8D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8637" y="358932"/>
            <a:ext cx="7385626" cy="516993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46E1F70-F3EA-4079-8C8F-F030C247A2EF}"/>
              </a:ext>
            </a:extLst>
          </p:cNvPr>
          <p:cNvSpPr txBox="1"/>
          <p:nvPr/>
        </p:nvSpPr>
        <p:spPr>
          <a:xfrm>
            <a:off x="123961" y="5934670"/>
            <a:ext cx="11582766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TSPO Gene Expression Levels in the Four Newly Described GBM Subtypes.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he graph </a:t>
            </a:r>
            <a:r>
              <a:rPr lang="en-US" sz="120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hows </a:t>
            </a:r>
            <a:r>
              <a:rPr lang="en-US" sz="1200" i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SPO</a:t>
            </a:r>
            <a:r>
              <a:rPr lang="en-US" sz="120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mRNA </a:t>
            </a:r>
            <a:r>
              <a:rPr lang="en-US" sz="120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gene expression levels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in each of the four GBM subtypes: </a:t>
            </a:r>
            <a:r>
              <a:rPr lang="en-US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roliferative/progenitor (PPR), mitochondrial (MTC), neuronal (NEU) and glycolytic/</a:t>
            </a:r>
            <a:r>
              <a:rPr lang="en-US" sz="1200" dirty="0" err="1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plurimetabolic</a:t>
            </a:r>
            <a:r>
              <a:rPr lang="en-US" sz="12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 (GPM), using the TCGA-GBM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dataset. p-value of the pairwise comparisons using t-test (with Bonferroni correction) are indicated in each graph. CPM= counts per million. </a:t>
            </a:r>
          </a:p>
        </p:txBody>
      </p:sp>
    </p:spTree>
    <p:extLst>
      <p:ext uri="{BB962C8B-B14F-4D97-AF65-F5344CB8AC3E}">
        <p14:creationId xmlns:p14="http://schemas.microsoft.com/office/powerpoint/2010/main" val="27948882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82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ana Azzam</dc:creator>
  <cp:lastModifiedBy>Diana Azzam</cp:lastModifiedBy>
  <cp:revision>5</cp:revision>
  <dcterms:created xsi:type="dcterms:W3CDTF">2021-08-25T03:32:18Z</dcterms:created>
  <dcterms:modified xsi:type="dcterms:W3CDTF">2021-08-27T01:14:41Z</dcterms:modified>
</cp:coreProperties>
</file>